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426" y="96"/>
      </p:cViewPr>
      <p:guideLst>
        <p:guide orient="horz" pos="214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BCAD0E-E8C9-4ACA-9C5A-0C7D1037F7EA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FBFF8E-4C17-4DA1-A15E-60F4CACF49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73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ECB67C3-8FAE-60E6-C3F1-2543606894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841" y="859382"/>
            <a:ext cx="2811600" cy="28116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3E4EA826-AE92-8A18-4AD8-2FF34C201354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117993" y="859382"/>
            <a:ext cx="2811600" cy="28116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F23FE4F2-99F1-94D0-0296-8B39519A63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9144" y="859382"/>
            <a:ext cx="2811600" cy="28116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251931" y="293474"/>
            <a:ext cx="31135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charset="0"/>
                <a:cs typeface="Times New Roman" panose="02020603050405020304" charset="0"/>
              </a:rPr>
              <a:t>Supplementary Figure S1. </a:t>
            </a:r>
            <a:endParaRPr kumimoji="1" lang="ja-JP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C243039-93FD-08B9-03C1-E5675971C88D}"/>
              </a:ext>
            </a:extLst>
          </p:cNvPr>
          <p:cNvSpPr txBox="1"/>
          <p:nvPr/>
        </p:nvSpPr>
        <p:spPr>
          <a:xfrm>
            <a:off x="285274" y="887923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13F7195-2618-2BE4-E1CA-9C2E8FBCF44E}"/>
              </a:ext>
            </a:extLst>
          </p:cNvPr>
          <p:cNvSpPr txBox="1"/>
          <p:nvPr/>
        </p:nvSpPr>
        <p:spPr>
          <a:xfrm>
            <a:off x="6026116" y="887923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0734430-65C4-FB25-09BD-8657C5E48560}"/>
              </a:ext>
            </a:extLst>
          </p:cNvPr>
          <p:cNvSpPr txBox="1"/>
          <p:nvPr/>
        </p:nvSpPr>
        <p:spPr>
          <a:xfrm>
            <a:off x="3146892" y="887923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A90FC8D3-2F0C-E8A4-BD34-CBA5071776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1810" y="3777160"/>
            <a:ext cx="2810500" cy="28105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D61618DE-BB69-3991-F473-AB49C1C2D9F3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114927" y="3776610"/>
            <a:ext cx="2811600" cy="28116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FAA1266B-A192-F02C-7376-80C96D0E9E15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5979144" y="3776610"/>
            <a:ext cx="2811600" cy="2811600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F388E06-022D-4123-A180-A01FABFE06C8}"/>
              </a:ext>
            </a:extLst>
          </p:cNvPr>
          <p:cNvSpPr txBox="1"/>
          <p:nvPr/>
        </p:nvSpPr>
        <p:spPr>
          <a:xfrm>
            <a:off x="285274" y="3815766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7AD599A-BBFB-3484-30E7-70C18C434B5A}"/>
              </a:ext>
            </a:extLst>
          </p:cNvPr>
          <p:cNvSpPr txBox="1"/>
          <p:nvPr/>
        </p:nvSpPr>
        <p:spPr>
          <a:xfrm>
            <a:off x="3146892" y="3815237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505DDFF-4256-3CA9-D8D4-165562DFD481}"/>
              </a:ext>
            </a:extLst>
          </p:cNvPr>
          <p:cNvSpPr txBox="1"/>
          <p:nvPr/>
        </p:nvSpPr>
        <p:spPr>
          <a:xfrm>
            <a:off x="6026116" y="3815237"/>
            <a:ext cx="32573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6514493-C78F-1069-D08E-2657E2F6F2EA}"/>
              </a:ext>
            </a:extLst>
          </p:cNvPr>
          <p:cNvSpPr txBox="1"/>
          <p:nvPr/>
        </p:nvSpPr>
        <p:spPr>
          <a:xfrm>
            <a:off x="1374748" y="2250391"/>
            <a:ext cx="7085683" cy="10345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. Histological features of the renal biopsy performed 3 months after the transplantation. (A, B) Light microscopy image showing minor glomerular abnormalities (A, PAS; B, HE; scale bars = 10.0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(C) Electron microscopy image showing minor glomerular abnormalities (scale bar = 5.0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(D, E, F)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mmunoperoxidas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taining image showing mild to moderate but substantial glomerular accumulation of cells positive for CD68 (clone: KP1; D), for CD3 (E), and for CD8 (F) (scale bars = 10.0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C4A8FA4-BA6D-7F25-507F-50D7136C8538}"/>
              </a:ext>
            </a:extLst>
          </p:cNvPr>
          <p:cNvSpPr txBox="1"/>
          <p:nvPr/>
        </p:nvSpPr>
        <p:spPr>
          <a:xfrm>
            <a:off x="1374748" y="1850281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charset="0"/>
                <a:cs typeface="Times New Roman" panose="02020603050405020304" charset="0"/>
              </a:rPr>
              <a:t>Legend</a:t>
            </a:r>
            <a:endParaRPr kumimoji="1" lang="ja-JP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9998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</TotalTime>
  <Words>120</Words>
  <Application>Microsoft Office PowerPoint</Application>
  <PresentationFormat>画面に合わせる (4:3)</PresentationFormat>
  <Paragraphs>9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尾田高志</dc:creator>
  <cp:lastModifiedBy>高志 尾田</cp:lastModifiedBy>
  <cp:revision>30</cp:revision>
  <dcterms:created xsi:type="dcterms:W3CDTF">2022-05-04T09:10:00Z</dcterms:created>
  <dcterms:modified xsi:type="dcterms:W3CDTF">2023-10-07T22:45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1.8.2.8498</vt:lpwstr>
  </property>
</Properties>
</file>